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27"/>
  </p:normalViewPr>
  <p:slideViewPr>
    <p:cSldViewPr snapToGrid="0" snapToObjects="1">
      <p:cViewPr varScale="1">
        <p:scale>
          <a:sx n="90" d="100"/>
          <a:sy n="90" d="100"/>
        </p:scale>
        <p:origin x="232" y="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17C63D-9BC6-C744-98B0-4CFB02DE43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CA2CB82-EFEA-1444-A018-FD4D7467B8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8365A9-DD77-4443-931C-90754C611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91A03E-6C3C-F44C-93DA-10A75978F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A5D1D1-84B2-FC4A-BF04-ECCEE21E6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274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56B376-9313-124F-9B49-EA954967F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F6EAC38-0F2A-B04C-949C-4A9080685D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23DBE3F-9FA9-1D4C-84BF-79E7B0769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F74840-B534-D34A-8E73-886923CE0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42A5E8-1E91-AC46-A65F-51B6CC449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074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DC2E12E-547A-6241-89EC-0E80E50E35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66EED2-90CE-5443-B7BE-C6A5CF9AAA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0FF074-B75F-D046-8900-57554EF76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BD70E9-FFF5-4747-B357-B00848BBA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4DF56A-12E1-F542-A7B2-8EEDD1DD0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848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4766B5-5A22-D34E-8A33-0CDB11A9E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01A19B-4616-574C-8D93-943784FE25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01A5CC-A480-A843-B848-1AD63935D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0CF12F-7990-F341-8581-BFE9CBAB5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FAC235-C027-304F-B255-DA0595FBA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134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2E86F0-0BDD-4C43-BD5B-84CF1D6B8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AE883AE-CDD2-8B45-86C5-01C587D82A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BA40D1-558A-C249-8981-79E5436A5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7A89FF-8C4B-0948-827A-AD8932011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6C2202-7717-CE49-8629-33AF78D82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124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9E29CA-1E3A-2D44-A383-C65125A6C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D32A9ED-784C-7742-82E2-801A304A47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ADD97D-4A21-DE42-838B-1CFF2C2C1C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2D16F9-5933-A648-9581-B992B80D9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13B391-F24D-224C-9982-0362B4755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C4605B-F016-9947-802E-186F55684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880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E4243C-0126-1E44-B46C-10B2F672D8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133CB28-E136-8743-841C-D5FA2107EA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02FA55-DC9A-A446-A609-EC384BD4B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B899ACC-3E5D-9E48-855C-479BA4B7F0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2EFDD61-69E0-F242-8D7E-A99991F85F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B70ED23-FEE1-064D-B510-8C50FDD1A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ADBA9E6-2769-DC41-B49A-89B22C8B7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1CD53B2-CAAB-0943-9F54-8CE1D0E35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301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2A3622-8086-3048-AED1-4BB73AE4E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9BB2A9F-A8C1-4946-B868-BC0406512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E830585-495B-8E4B-A343-BBD93E220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F81A9F6-ACB2-2B44-9393-D5010AA5B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64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B2CEC4A-4547-5C43-94CD-10347EFBC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1208292-FEF7-4F4C-BC5B-EF28D56F8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14B4423-2E18-414B-8BA1-6172D718D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3931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29C8F4-ED66-8543-858F-A086AD3CD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C2FCFE-6A1A-1B48-9370-3C3E3244A3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2CB634-D2E0-B74F-8AE8-3D55348AE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140865-9BA5-7941-B322-1B379DD84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9E22E6-3552-DF4A-8847-C0E651D16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469D2C-5A68-0E4E-9EC8-B8E1A0010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88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92E1A2-C5C8-1C4D-96DC-2EC5A7A6C7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7AB703E-B27A-904C-8E9B-A44E7013FE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F266B22-D064-5A4C-824C-37DA1DF828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8EA34EB-AF91-DF40-AA20-6B229283A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D819614-1BC2-9A4F-8632-7DD5412DB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761EA6B-F55F-524B-B2F5-A2DF7B2BE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571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EF5AA8C-BBF5-9148-9B66-A5A231BF8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453890-C896-D547-B79B-3B4022B929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8F6E4C-2394-EE4B-967A-8DD639D81D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ABC1D-65B4-EB42-AEDE-96F272E5B48A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0C9D49-104A-7A40-AD10-8C9F88C986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CB28D7-D92A-0149-B737-B57883F7A0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0C690-D02E-8547-B785-FC131CD74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987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B68DA96-E19A-7848-8D70-A2D37D81272D}"/>
              </a:ext>
            </a:extLst>
          </p:cNvPr>
          <p:cNvSpPr txBox="1"/>
          <p:nvPr/>
        </p:nvSpPr>
        <p:spPr>
          <a:xfrm>
            <a:off x="3101111" y="500063"/>
            <a:ext cx="59897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Video S2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D decay-rate map of </a:t>
            </a:r>
            <a:r>
              <a:rPr lang="en-US" altLang="ja-JP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-PDT in the tumor-bearing leg.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Kimura_Suppl_Video_S2.mp4" descr="Kimura_Suppl_Video_S2.mp4">
            <a:hlinkClick r:id="" action="ppaction://media"/>
            <a:extLst>
              <a:ext uri="{FF2B5EF4-FFF2-40B4-BE49-F238E27FC236}">
                <a16:creationId xmlns:a16="http://schemas.microsoft.com/office/drawing/2014/main" id="{FDC3DA7E-79FF-D34A-ABA4-2D792161D76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798901" y="1643119"/>
            <a:ext cx="6594197" cy="4714818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42094E7-4EA1-BA49-9E7B-7EC3A3B78957}"/>
              </a:ext>
            </a:extLst>
          </p:cNvPr>
          <p:cNvSpPr txBox="1"/>
          <p:nvPr/>
        </p:nvSpPr>
        <p:spPr>
          <a:xfrm>
            <a:off x="5486400" y="3121223"/>
            <a:ext cx="4905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ail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5237985-0222-B54B-84B1-1A2F3CF57ED0}"/>
              </a:ext>
            </a:extLst>
          </p:cNvPr>
          <p:cNvSpPr txBox="1"/>
          <p:nvPr/>
        </p:nvSpPr>
        <p:spPr>
          <a:xfrm>
            <a:off x="5950361" y="4419795"/>
            <a:ext cx="18907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umor-bearing leg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ACF18A-8632-9244-94B1-CC9372B0DC41}"/>
              </a:ext>
            </a:extLst>
          </p:cNvPr>
          <p:cNvSpPr txBox="1"/>
          <p:nvPr/>
        </p:nvSpPr>
        <p:spPr>
          <a:xfrm>
            <a:off x="8401051" y="1714501"/>
            <a:ext cx="34427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edox-sensitive probe:</a:t>
            </a:r>
          </a:p>
          <a:p>
            <a:r>
              <a:rPr kumimoji="1"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-labaled perdeuterated 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Tempone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-PDT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E3DD4F0-9BB2-5A4D-ADD2-3328DF3D23F3}"/>
              </a:ext>
            </a:extLst>
          </p:cNvPr>
          <p:cNvSpPr txBox="1"/>
          <p:nvPr/>
        </p:nvSpPr>
        <p:spPr>
          <a:xfrm>
            <a:off x="8401051" y="3096356"/>
            <a:ext cx="3020379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eld-of-view: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.5 mm x 37.5 mm x 37.5 mm</a:t>
            </a:r>
          </a:p>
          <a:p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mage matrix: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96 x 96 x 96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9C89E96-8614-4C47-B267-C0A72D488B5D}"/>
              </a:ext>
            </a:extLst>
          </p:cNvPr>
          <p:cNvSpPr txBox="1"/>
          <p:nvPr/>
        </p:nvSpPr>
        <p:spPr>
          <a:xfrm>
            <a:off x="770570" y="1714501"/>
            <a:ext cx="27366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mpressed sensing-based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mage reconstruction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D3CADB6-2D95-9040-8E9E-6014FD890C66}"/>
              </a:ext>
            </a:extLst>
          </p:cNvPr>
          <p:cNvSpPr txBox="1"/>
          <p:nvPr/>
        </p:nvSpPr>
        <p:spPr>
          <a:xfrm>
            <a:off x="770569" y="5280719"/>
            <a:ext cx="273664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 threshold of 25% of maximum signal intensity was applied to the decay-rate computation.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DC9FFEC-8346-3249-AE84-8694B28C2E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2653302" y="3818487"/>
            <a:ext cx="2433997" cy="24081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73C50BA-36A8-1C42-9427-B5E119F1D99F}"/>
              </a:ext>
            </a:extLst>
          </p:cNvPr>
          <p:cNvSpPr txBox="1"/>
          <p:nvPr/>
        </p:nvSpPr>
        <p:spPr>
          <a:xfrm rot="16200000">
            <a:off x="2562759" y="3661465"/>
            <a:ext cx="11769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ecay rate</a:t>
            </a:r>
          </a:p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min</a:t>
            </a:r>
            <a:r>
              <a:rPr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kumimoji="1"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9132657-1EA4-724B-BBC1-7BD5362C9FC2}"/>
              </a:ext>
            </a:extLst>
          </p:cNvPr>
          <p:cNvSpPr txBox="1"/>
          <p:nvPr/>
        </p:nvSpPr>
        <p:spPr>
          <a:xfrm>
            <a:off x="3252102" y="2552621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D1B68FE-AD18-E34E-935C-3E889CF18D13}"/>
              </a:ext>
            </a:extLst>
          </p:cNvPr>
          <p:cNvSpPr txBox="1"/>
          <p:nvPr/>
        </p:nvSpPr>
        <p:spPr>
          <a:xfrm>
            <a:off x="3279891" y="4986618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91721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8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2</Words>
  <Application>Microsoft Macintosh PowerPoint</Application>
  <PresentationFormat>ワイド画面</PresentationFormat>
  <Paragraphs>19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田　拓</dc:creator>
  <cp:lastModifiedBy>平田　拓</cp:lastModifiedBy>
  <cp:revision>2</cp:revision>
  <dcterms:created xsi:type="dcterms:W3CDTF">2020-12-29T05:30:53Z</dcterms:created>
  <dcterms:modified xsi:type="dcterms:W3CDTF">2021-01-04T01:09:33Z</dcterms:modified>
</cp:coreProperties>
</file>